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9" d="100"/>
          <a:sy n="79" d="100"/>
        </p:scale>
        <p:origin x="308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41CA0-D957-4E01-85A8-F044409F0407}" type="datetimeFigureOut">
              <a:rPr lang="en-GB" smtClean="0"/>
              <a:t>06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4AF2C-8AAD-477B-AD40-10C59D7A1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6883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41CA0-D957-4E01-85A8-F044409F0407}" type="datetimeFigureOut">
              <a:rPr lang="en-GB" smtClean="0"/>
              <a:t>06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4AF2C-8AAD-477B-AD40-10C59D7A1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16350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41CA0-D957-4E01-85A8-F044409F0407}" type="datetimeFigureOut">
              <a:rPr lang="en-GB" smtClean="0"/>
              <a:t>06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4AF2C-8AAD-477B-AD40-10C59D7A1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94333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41CA0-D957-4E01-85A8-F044409F0407}" type="datetimeFigureOut">
              <a:rPr lang="en-GB" smtClean="0"/>
              <a:t>06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4AF2C-8AAD-477B-AD40-10C59D7A1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7150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41CA0-D957-4E01-85A8-F044409F0407}" type="datetimeFigureOut">
              <a:rPr lang="en-GB" smtClean="0"/>
              <a:t>06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4AF2C-8AAD-477B-AD40-10C59D7A1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70934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41CA0-D957-4E01-85A8-F044409F0407}" type="datetimeFigureOut">
              <a:rPr lang="en-GB" smtClean="0"/>
              <a:t>06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4AF2C-8AAD-477B-AD40-10C59D7A1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75018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41CA0-D957-4E01-85A8-F044409F0407}" type="datetimeFigureOut">
              <a:rPr lang="en-GB" smtClean="0"/>
              <a:t>06/03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4AF2C-8AAD-477B-AD40-10C59D7A1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32758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41CA0-D957-4E01-85A8-F044409F0407}" type="datetimeFigureOut">
              <a:rPr lang="en-GB" smtClean="0"/>
              <a:t>06/03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4AF2C-8AAD-477B-AD40-10C59D7A1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3618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41CA0-D957-4E01-85A8-F044409F0407}" type="datetimeFigureOut">
              <a:rPr lang="en-GB" smtClean="0"/>
              <a:t>06/03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4AF2C-8AAD-477B-AD40-10C59D7A1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71317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41CA0-D957-4E01-85A8-F044409F0407}" type="datetimeFigureOut">
              <a:rPr lang="en-GB" smtClean="0"/>
              <a:t>06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4AF2C-8AAD-477B-AD40-10C59D7A1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20396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41CA0-D957-4E01-85A8-F044409F0407}" type="datetimeFigureOut">
              <a:rPr lang="en-GB" smtClean="0"/>
              <a:t>06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4AF2C-8AAD-477B-AD40-10C59D7A1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56928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641CA0-D957-4E01-85A8-F044409F0407}" type="datetimeFigureOut">
              <a:rPr lang="en-GB" smtClean="0"/>
              <a:t>06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B4AF2C-8AAD-477B-AD40-10C59D7A1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5392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601A901-5C07-4E1F-BD1F-4A9A22D0903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51603147"/>
              </p:ext>
            </p:extLst>
          </p:nvPr>
        </p:nvGraphicFramePr>
        <p:xfrm>
          <a:off x="704850" y="801880"/>
          <a:ext cx="5619748" cy="876042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11875">
                  <a:extLst>
                    <a:ext uri="{9D8B030D-6E8A-4147-A177-3AD203B41FA5}">
                      <a16:colId xmlns:a16="http://schemas.microsoft.com/office/drawing/2014/main" val="4063082691"/>
                    </a:ext>
                  </a:extLst>
                </a:gridCol>
                <a:gridCol w="1438124">
                  <a:extLst>
                    <a:ext uri="{9D8B030D-6E8A-4147-A177-3AD203B41FA5}">
                      <a16:colId xmlns:a16="http://schemas.microsoft.com/office/drawing/2014/main" val="2833827417"/>
                    </a:ext>
                  </a:extLst>
                </a:gridCol>
                <a:gridCol w="1343285">
                  <a:extLst>
                    <a:ext uri="{9D8B030D-6E8A-4147-A177-3AD203B41FA5}">
                      <a16:colId xmlns:a16="http://schemas.microsoft.com/office/drawing/2014/main" val="1675091947"/>
                    </a:ext>
                  </a:extLst>
                </a:gridCol>
                <a:gridCol w="1326464">
                  <a:extLst>
                    <a:ext uri="{9D8B030D-6E8A-4147-A177-3AD203B41FA5}">
                      <a16:colId xmlns:a16="http://schemas.microsoft.com/office/drawing/2014/main" val="3682194263"/>
                    </a:ext>
                  </a:extLst>
                </a:gridCol>
              </a:tblGrid>
              <a:tr h="139028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GB" sz="105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ltivar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81390266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A</a:t>
                      </a:r>
                    </a:p>
                  </a:txBody>
                  <a:tcPr marL="5182" marR="5182" marT="518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5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B 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5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A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5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A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77726312"/>
                  </a:ext>
                </a:extLst>
              </a:tr>
              <a:tr h="1583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19wm542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-Quartz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-Quartz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27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786748"/>
                  </a:ext>
                </a:extLst>
              </a:tr>
              <a:tr h="142682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e.umb il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huac 7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17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17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41558661"/>
                  </a:ext>
                </a:extLst>
              </a:tr>
              <a:tr h="142682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etista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alon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Gralha Azul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Camboatá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8346266"/>
                  </a:ext>
                </a:extLst>
              </a:tr>
              <a:tr h="142682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254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etist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Guabiju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Gralha Azul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40045"/>
                  </a:ext>
                </a:extLst>
              </a:tr>
              <a:tr h="142682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329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 2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 11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Louro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62066313"/>
                  </a:ext>
                </a:extLst>
              </a:tr>
              <a:tr h="142682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Guamirim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209 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 11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Parrudo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9735126"/>
                  </a:ext>
                </a:extLst>
              </a:tr>
              <a:tr h="142682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 104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22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PR 14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Timbaúva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83130391"/>
                  </a:ext>
                </a:extLst>
              </a:tr>
              <a:tr h="142682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 115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26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mpea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ndacep Raíze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8082815"/>
                  </a:ext>
                </a:extLst>
              </a:tr>
              <a:tr h="142682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 154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32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BIO Sinuelo</a:t>
                      </a: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Ônix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3484735"/>
                  </a:ext>
                </a:extLst>
              </a:tr>
              <a:tr h="142682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mbrapa 22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33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BIO Sinuel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2090749"/>
                  </a:ext>
                </a:extLst>
              </a:tr>
              <a:tr h="142682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ndacep 300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Camboatá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88033706"/>
                  </a:ext>
                </a:extLst>
              </a:tr>
              <a:tr h="142682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ndacep Horizonte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Gaivota (Albatroz)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7133373"/>
                  </a:ext>
                </a:extLst>
              </a:tr>
              <a:tr h="142682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ndacep Nova Era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Gralha Azul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9814440"/>
                  </a:ext>
                </a:extLst>
              </a:tr>
              <a:tr h="142682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rfim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Guabiju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76648998"/>
                  </a:ext>
                </a:extLst>
              </a:tr>
              <a:tr h="142682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 1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Guamirim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69273714"/>
                  </a:ext>
                </a:extLst>
              </a:tr>
              <a:tr h="142682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13-32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Pardel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4715318"/>
                  </a:ext>
                </a:extLst>
              </a:tr>
              <a:tr h="142682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13-69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Parrud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9920414"/>
                  </a:ext>
                </a:extLst>
              </a:tr>
              <a:tr h="142682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c Vigore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Tangará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164781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S Umbu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3685966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mpeir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7463840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 11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7858233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 11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3018681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 11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87981306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 12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8256263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 12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82144695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ndacep 30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22675425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ndacep 5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5314720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ndacep 5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29029863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ndacep Bravo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7206712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ndacep Horizont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0011163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ndacep Nova Era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5392944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ndacep Raíze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25734856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PR 14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43615953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PR 8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16881848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rfim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27013973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Ônix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0297695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 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1432052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mpea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12305098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fir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81835974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er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66099200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BIO Alvorad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9240852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BIO Iguaçú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1743675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BIO Itaipu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9065568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BIO Mestr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7371766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BIO Pioneir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83665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BIO Selet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9315093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BIO Sinuel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2274002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BIO Tibagi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6316336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C Triunf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1394190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pazi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35955944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rquez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068029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lent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7858129"/>
                  </a:ext>
                </a:extLst>
              </a:tr>
              <a:tr h="13902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quea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2" marR="5182" marT="518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558781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6D8743D-873C-46D4-B7D8-3E79E3812C66}"/>
              </a:ext>
            </a:extLst>
          </p:cNvPr>
          <p:cNvSpPr txBox="1"/>
          <p:nvPr/>
        </p:nvSpPr>
        <p:spPr>
          <a:xfrm>
            <a:off x="446567" y="127591"/>
            <a:ext cx="61987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Cultivars displaying a 98% similar haplotype to Anahuac 75 at the 1A head resistance QTL and to BR 18-Terena at the 2B, 4A and 5A head resistance QTL.</a:t>
            </a:r>
          </a:p>
        </p:txBody>
      </p:sp>
    </p:spTree>
    <p:extLst>
      <p:ext uri="{BB962C8B-B14F-4D97-AF65-F5344CB8AC3E}">
        <p14:creationId xmlns:p14="http://schemas.microsoft.com/office/powerpoint/2010/main" val="39895149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19</TotalTime>
  <Words>208</Words>
  <Application>Microsoft Office PowerPoint</Application>
  <PresentationFormat>A4 Paper (210x297 mm)</PresentationFormat>
  <Paragraphs>9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chel Goddard (JIC)</dc:creator>
  <cp:lastModifiedBy>Rachel Goddard (JIC)</cp:lastModifiedBy>
  <cp:revision>28</cp:revision>
  <dcterms:created xsi:type="dcterms:W3CDTF">2019-11-20T14:10:25Z</dcterms:created>
  <dcterms:modified xsi:type="dcterms:W3CDTF">2020-03-06T13:56:57Z</dcterms:modified>
</cp:coreProperties>
</file>